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EA5914-051D-4911-B2EE-339DEE34B17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389EC0-50BE-40EE-B5F7-C9763BFAD7F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493565-F8A2-4E16-96F9-9045E37E787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9FA7E4-9C4E-4910-9784-A68EBEDEC3D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F054AB-EE7F-45B6-9370-0B2A986E835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DAC769-4315-4ACF-8707-E9BEBC34C51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D096F1-1492-4AA0-BF4C-36DA1EC81E4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1C5FAD-85BD-482D-BDE4-6C76FDF73F1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6BD591-2229-4115-94D9-5A98569333C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F3F903-1CBA-4434-83F0-E414F6067D7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F8F4B3-E82E-4F07-AA94-CA4CF9B19A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4B6782-7914-4964-A1D1-F28477E4FE5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762A01F-F9EE-467D-B08A-791466676E0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219320" y="1219320"/>
            <a:ext cx="2666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 flipH="1">
            <a:off x="4648320" y="1447920"/>
            <a:ext cx="259056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4343400" y="1168560"/>
            <a:ext cx="6858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ff0000"/>
                </a:solidFill>
                <a:latin typeface="Arial"/>
              </a:rPr>
              <a:t>*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2362320" y="1030320"/>
            <a:ext cx="2908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GCTATCAA           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3191040" y="2514600"/>
            <a:ext cx="68580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ff0000"/>
                </a:solidFill>
                <a:latin typeface="Arial"/>
              </a:rPr>
              <a:t>*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3330720" y="2552760"/>
            <a:ext cx="761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T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 flipH="1">
            <a:off x="3809520" y="2743200"/>
            <a:ext cx="25909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270080" y="2540160"/>
            <a:ext cx="2514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3890880" y="2538360"/>
            <a:ext cx="3784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2311560" y="3543480"/>
            <a:ext cx="19810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0000"/>
                </a:solidFill>
                <a:latin typeface="Arial"/>
              </a:rPr>
              <a:t>*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GATAGT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 flipH="1">
            <a:off x="3758760" y="3809880"/>
            <a:ext cx="25909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228680" y="3606840"/>
            <a:ext cx="2514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3860640" y="3606840"/>
            <a:ext cx="3784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 flipH="1">
            <a:off x="3835080" y="5105520"/>
            <a:ext cx="259092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1295280" y="4902120"/>
            <a:ext cx="2514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3940200" y="4915080"/>
            <a:ext cx="3784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3772080" y="4673520"/>
            <a:ext cx="304560" cy="241560"/>
          </a:xfrm>
          <a:custGeom>
            <a:avLst/>
            <a:gdLst/>
            <a:ahLst/>
            <a:rect l="l" t="t" r="r" b="b"/>
            <a:pathLst>
              <a:path w="192" h="152">
                <a:moveTo>
                  <a:pt x="48" y="152"/>
                </a:moveTo>
                <a:cubicBezTo>
                  <a:pt x="24" y="116"/>
                  <a:pt x="0" y="80"/>
                  <a:pt x="0" y="56"/>
                </a:cubicBezTo>
                <a:cubicBezTo>
                  <a:pt x="0" y="32"/>
                  <a:pt x="24" y="16"/>
                  <a:pt x="48" y="8"/>
                </a:cubicBezTo>
                <a:cubicBezTo>
                  <a:pt x="72" y="0"/>
                  <a:pt x="120" y="0"/>
                  <a:pt x="144" y="8"/>
                </a:cubicBezTo>
                <a:cubicBezTo>
                  <a:pt x="168" y="16"/>
                  <a:pt x="192" y="40"/>
                  <a:pt x="192" y="56"/>
                </a:cubicBezTo>
                <a:cubicBezTo>
                  <a:pt x="192" y="72"/>
                  <a:pt x="160" y="88"/>
                  <a:pt x="144" y="104"/>
                </a:cubicBezTo>
                <a:cubicBezTo>
                  <a:pt x="128" y="120"/>
                  <a:pt x="104" y="144"/>
                  <a:pt x="96" y="152"/>
                </a:cubicBezTo>
              </a:path>
            </a:pathLst>
          </a:custGeom>
          <a:noFill/>
          <a:ln w="1908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3708360" y="3365640"/>
            <a:ext cx="304920" cy="241200"/>
          </a:xfrm>
          <a:custGeom>
            <a:avLst/>
            <a:gdLst/>
            <a:ahLst/>
            <a:rect l="l" t="t" r="r" b="b"/>
            <a:pathLst>
              <a:path w="192" h="152">
                <a:moveTo>
                  <a:pt x="48" y="152"/>
                </a:moveTo>
                <a:cubicBezTo>
                  <a:pt x="24" y="116"/>
                  <a:pt x="0" y="80"/>
                  <a:pt x="0" y="56"/>
                </a:cubicBezTo>
                <a:cubicBezTo>
                  <a:pt x="0" y="32"/>
                  <a:pt x="24" y="16"/>
                  <a:pt x="48" y="8"/>
                </a:cubicBezTo>
                <a:cubicBezTo>
                  <a:pt x="72" y="0"/>
                  <a:pt x="120" y="0"/>
                  <a:pt x="144" y="8"/>
                </a:cubicBezTo>
                <a:cubicBezTo>
                  <a:pt x="168" y="16"/>
                  <a:pt x="192" y="40"/>
                  <a:pt x="192" y="56"/>
                </a:cubicBezTo>
                <a:cubicBezTo>
                  <a:pt x="192" y="72"/>
                  <a:pt x="160" y="88"/>
                  <a:pt x="144" y="104"/>
                </a:cubicBezTo>
                <a:cubicBezTo>
                  <a:pt x="128" y="120"/>
                  <a:pt x="104" y="144"/>
                  <a:pt x="96" y="152"/>
                </a:cubicBezTo>
              </a:path>
            </a:pathLst>
          </a:custGeom>
          <a:noFill/>
          <a:ln w="1908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3889440" y="1219320"/>
            <a:ext cx="761760" cy="0"/>
          </a:xfrm>
          <a:prstGeom prst="line">
            <a:avLst/>
          </a:prstGeom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4660920" y="1219320"/>
            <a:ext cx="3009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2197080" y="4826160"/>
            <a:ext cx="19810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0000"/>
                </a:solidFill>
                <a:latin typeface="Arial"/>
              </a:rPr>
              <a:t>*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CGATAGT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533520" y="5638680"/>
            <a:ext cx="8229600" cy="550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938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Fig S-2: Sequence contexts show false positives arising from misincorporation for PAP-A and formation of heteroduplex and mis-</a:t>
            </a:r>
            <a:r>
              <a:rPr b="0" lang="en-US" sz="1500" spc="-1" strike="noStrike">
                <a:solidFill>
                  <a:srgbClr val="000000"/>
                </a:solidFill>
                <a:latin typeface="Arial"/>
                <a:ea typeface="宋体"/>
              </a:rPr>
              <a:t>pyrophosphorolysis (Blue arrow by asterisk) for MAP</a:t>
            </a: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. 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3657600" y="609480"/>
            <a:ext cx="1219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5 bp dele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4267080" y="851040"/>
            <a:ext cx="0" cy="30456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4483080" y="2222640"/>
            <a:ext cx="1219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5 bp dele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 flipH="1">
            <a:off x="4140360" y="2362320"/>
            <a:ext cx="3808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4394160" y="3327480"/>
            <a:ext cx="1219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5 bp dele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4457880" y="4635360"/>
            <a:ext cx="1218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5 bp delet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 flipH="1">
            <a:off x="4038120" y="3492360"/>
            <a:ext cx="38124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 flipH="1">
            <a:off x="4114800" y="4775040"/>
            <a:ext cx="3808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635040" y="2336760"/>
            <a:ext cx="762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622440" y="990720"/>
            <a:ext cx="761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647640" y="3390840"/>
            <a:ext cx="762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660240" y="4686480"/>
            <a:ext cx="762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2298600" y="2324160"/>
            <a:ext cx="2908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GTGAGAAA         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2260440" y="3392640"/>
            <a:ext cx="2908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GCTATCAA         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2336760" y="4686480"/>
            <a:ext cx="2908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GCTATCAA          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 flipV="1">
            <a:off x="2058840" y="5028840"/>
            <a:ext cx="228600" cy="152280"/>
          </a:xfrm>
          <a:prstGeom prst="line">
            <a:avLst/>
          </a:prstGeom>
          <a:ln w="9360">
            <a:solidFill>
              <a:srgbClr val="3333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 flipV="1">
            <a:off x="2179800" y="3744720"/>
            <a:ext cx="228600" cy="152280"/>
          </a:xfrm>
          <a:prstGeom prst="line">
            <a:avLst/>
          </a:prstGeom>
          <a:ln w="9360">
            <a:solidFill>
              <a:srgbClr val="3333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 flipV="1">
            <a:off x="3049560" y="2731680"/>
            <a:ext cx="228600" cy="152280"/>
          </a:xfrm>
          <a:prstGeom prst="line">
            <a:avLst/>
          </a:prstGeom>
          <a:ln w="9360">
            <a:solidFill>
              <a:srgbClr val="3333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 flipV="1">
            <a:off x="4192560" y="1382400"/>
            <a:ext cx="228600" cy="152280"/>
          </a:xfrm>
          <a:prstGeom prst="line">
            <a:avLst/>
          </a:prstGeom>
          <a:ln w="9360">
            <a:solidFill>
              <a:srgbClr val="3333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7772400" y="946080"/>
            <a:ext cx="114300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1bp mismatch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7772400" y="2133720"/>
            <a:ext cx="114300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2bp mismatch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7772400" y="3352680"/>
            <a:ext cx="114300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8bp mismatch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7772400" y="4648320"/>
            <a:ext cx="114300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9bp mismatch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6" name=""/>
          <p:cNvGrpSpPr/>
          <p:nvPr/>
        </p:nvGrpSpPr>
        <p:grpSpPr>
          <a:xfrm>
            <a:off x="3689280" y="2209680"/>
            <a:ext cx="343080" cy="317520"/>
            <a:chOff x="3689280" y="2209680"/>
            <a:chExt cx="343080" cy="317520"/>
          </a:xfrm>
        </p:grpSpPr>
        <p:sp>
          <p:nvSpPr>
            <p:cNvPr id="87" name=""/>
            <p:cNvSpPr/>
            <p:nvPr/>
          </p:nvSpPr>
          <p:spPr>
            <a:xfrm>
              <a:off x="3689280" y="2209680"/>
              <a:ext cx="254160" cy="317520"/>
            </a:xfrm>
            <a:custGeom>
              <a:avLst/>
              <a:gdLst/>
              <a:ahLst/>
              <a:rect l="l" t="t" r="r" b="b"/>
              <a:pathLst>
                <a:path w="160" h="200">
                  <a:moveTo>
                    <a:pt x="64" y="200"/>
                  </a:moveTo>
                  <a:cubicBezTo>
                    <a:pt x="44" y="188"/>
                    <a:pt x="24" y="176"/>
                    <a:pt x="16" y="152"/>
                  </a:cubicBezTo>
                  <a:cubicBezTo>
                    <a:pt x="8" y="128"/>
                    <a:pt x="0" y="80"/>
                    <a:pt x="16" y="56"/>
                  </a:cubicBezTo>
                  <a:cubicBezTo>
                    <a:pt x="32" y="32"/>
                    <a:pt x="88" y="16"/>
                    <a:pt x="112" y="8"/>
                  </a:cubicBezTo>
                  <a:cubicBezTo>
                    <a:pt x="136" y="0"/>
                    <a:pt x="152" y="8"/>
                    <a:pt x="160" y="8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3867120" y="2222280"/>
              <a:ext cx="165240" cy="304920"/>
            </a:xfrm>
            <a:custGeom>
              <a:avLst/>
              <a:gdLst/>
              <a:ahLst/>
              <a:rect l="l" t="t" r="r" b="b"/>
              <a:pathLst>
                <a:path w="104" h="192">
                  <a:moveTo>
                    <a:pt x="48" y="0"/>
                  </a:moveTo>
                  <a:cubicBezTo>
                    <a:pt x="68" y="16"/>
                    <a:pt x="88" y="32"/>
                    <a:pt x="96" y="48"/>
                  </a:cubicBezTo>
                  <a:cubicBezTo>
                    <a:pt x="104" y="64"/>
                    <a:pt x="104" y="80"/>
                    <a:pt x="96" y="96"/>
                  </a:cubicBezTo>
                  <a:cubicBezTo>
                    <a:pt x="88" y="112"/>
                    <a:pt x="64" y="128"/>
                    <a:pt x="48" y="144"/>
                  </a:cubicBezTo>
                  <a:cubicBezTo>
                    <a:pt x="32" y="160"/>
                    <a:pt x="8" y="184"/>
                    <a:pt x="0" y="192"/>
                  </a:cubicBezTo>
                </a:path>
              </a:pathLst>
            </a:custGeom>
            <a:noFill/>
            <a:ln w="19080">
              <a:solidFill>
                <a:srgbClr val="ff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9" name=""/>
          <p:cNvSpPr/>
          <p:nvPr/>
        </p:nvSpPr>
        <p:spPr>
          <a:xfrm>
            <a:off x="3581280" y="1981080"/>
            <a:ext cx="152640" cy="30492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3300480" y="1760400"/>
            <a:ext cx="609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15 b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0-17T22:18:06Z</dcterms:created>
  <dc:creator>cbuzin</dc:creator>
  <dc:description/>
  <dc:language>en-US</dc:language>
  <cp:lastModifiedBy>cbuzin</cp:lastModifiedBy>
  <dcterms:modified xsi:type="dcterms:W3CDTF">2008-10-17T22:18:26Z</dcterms:modified>
  <cp:revision>1</cp:revision>
  <dc:subject/>
  <dc:title>Slide 1</dc:title>
</cp:coreProperties>
</file>